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media/image3.png" ContentType="image/pn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6858000" cy="9907588"/>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E3A9DA21-4EEF-47B4-89A8-ED876E898C98}"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514440" y="880560"/>
            <a:ext cx="582912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514440" y="2862360"/>
            <a:ext cx="5829120" cy="28350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514440" y="5967000"/>
            <a:ext cx="5829120" cy="28350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37C2D018-AFC1-427E-9D9B-7A6B47F2C9E7}"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514440" y="880560"/>
            <a:ext cx="582912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514440" y="2862360"/>
            <a:ext cx="2844360" cy="28350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3501360" y="2862360"/>
            <a:ext cx="2844360" cy="28350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514440" y="5967000"/>
            <a:ext cx="2844360" cy="28350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3501360" y="5967000"/>
            <a:ext cx="2844360" cy="28350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D3A12764-C83F-46A1-9D1D-7C20BEBA3EA5}"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514440" y="880560"/>
            <a:ext cx="582912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514440" y="2862360"/>
            <a:ext cx="1876680" cy="28350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2485440" y="2862360"/>
            <a:ext cx="1876680" cy="28350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4456080" y="2862360"/>
            <a:ext cx="1876680" cy="28350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514440" y="5967000"/>
            <a:ext cx="1876680" cy="28350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2485440" y="5967000"/>
            <a:ext cx="1876680" cy="28350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4456080" y="5967000"/>
            <a:ext cx="1876680" cy="28350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0059C298-3E7F-4C73-8E8F-FA33E4919828}"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514440" y="880560"/>
            <a:ext cx="582912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514440" y="2862360"/>
            <a:ext cx="5829120" cy="594360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5BF4B22B-A20F-46B8-A23F-73E9B018694C}"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514440" y="880560"/>
            <a:ext cx="582912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514440" y="2862360"/>
            <a:ext cx="5829120" cy="59436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79839ABE-8F1B-40A9-A936-6653835D0AFF}"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514440" y="880560"/>
            <a:ext cx="582912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514440" y="2862360"/>
            <a:ext cx="2844360" cy="59436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3501360" y="2862360"/>
            <a:ext cx="2844360" cy="59436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E28B8DD5-80BC-4E3F-954B-E0DA2686A8FD}"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514440" y="880560"/>
            <a:ext cx="582912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D0808A32-EA78-4D1C-BAB1-4F9409BB3A4E}"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514440" y="880560"/>
            <a:ext cx="5829120" cy="76557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0B6D840F-230A-4768-9416-09B639ACB492}"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514440" y="880560"/>
            <a:ext cx="582912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514440" y="2862360"/>
            <a:ext cx="2844360" cy="28350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3501360" y="2862360"/>
            <a:ext cx="2844360" cy="59436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514440" y="5967000"/>
            <a:ext cx="2844360" cy="28350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6D20630D-86E2-4540-9A81-D4D5E4F3CD57}"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514440" y="880560"/>
            <a:ext cx="582912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514440" y="2862360"/>
            <a:ext cx="2844360" cy="59436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3501360" y="2862360"/>
            <a:ext cx="2844360" cy="28350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3501360" y="5967000"/>
            <a:ext cx="2844360" cy="28350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5FA85E9F-6C09-4DF2-BAB4-82494805F56D}"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514440" y="880560"/>
            <a:ext cx="582912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514440" y="2862360"/>
            <a:ext cx="2844360" cy="28350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3501360" y="2862360"/>
            <a:ext cx="2844360" cy="28350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514440" y="5967000"/>
            <a:ext cx="5829120" cy="283500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241605E2-414E-43A4-BF6E-C78BB8353BE6}"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514440" y="880560"/>
            <a:ext cx="582912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514440" y="2862360"/>
            <a:ext cx="5829120" cy="594360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514080" y="9024480"/>
            <a:ext cx="1428840" cy="66060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date/time&gt;</a:t>
            </a:r>
            <a:endParaRPr b="0" lang="en-US" sz="1400" spc="-1" strike="noStrike">
              <a:solidFill>
                <a:srgbClr val="000000"/>
              </a:solidFill>
              <a:latin typeface="Arial"/>
            </a:endParaRPr>
          </a:p>
        </p:txBody>
      </p:sp>
      <p:sp>
        <p:nvSpPr>
          <p:cNvPr id="3" name="PlaceHolder 4"/>
          <p:cNvSpPr>
            <a:spLocks noGrp="1"/>
          </p:cNvSpPr>
          <p:nvPr>
            <p:ph type="ftr" idx="2"/>
          </p:nvPr>
        </p:nvSpPr>
        <p:spPr>
          <a:xfrm>
            <a:off x="2343240" y="9024480"/>
            <a:ext cx="2171520" cy="66060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footer&gt;</a:t>
            </a:r>
            <a:endParaRPr b="0" lang="en-US" sz="1400" spc="-1" strike="noStrike">
              <a:solidFill>
                <a:srgbClr val="000000"/>
              </a:solidFill>
              <a:latin typeface="Arial"/>
            </a:endParaRPr>
          </a:p>
        </p:txBody>
      </p:sp>
      <p:sp>
        <p:nvSpPr>
          <p:cNvPr id="4" name="PlaceHolder 5"/>
          <p:cNvSpPr>
            <a:spLocks noGrp="1"/>
          </p:cNvSpPr>
          <p:nvPr>
            <p:ph type="sldNum" idx="3"/>
          </p:nvPr>
        </p:nvSpPr>
        <p:spPr>
          <a:xfrm>
            <a:off x="4915080" y="9024480"/>
            <a:ext cx="1428480" cy="66060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AE38C7C8-FAEE-4BEE-B17A-ED38CA381EEE}"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image" Target="../media/image3.png"/><Relationship Id="rId4" Type="http://schemas.openxmlformats.org/officeDocument/2006/relationships/slideLayout" Target="../slideLayouts/slideLayout2.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1" name=""/>
          <p:cNvSpPr/>
          <p:nvPr/>
        </p:nvSpPr>
        <p:spPr>
          <a:xfrm>
            <a:off x="1447920" y="533520"/>
            <a:ext cx="3989160" cy="3070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u="sng">
                <a:solidFill>
                  <a:srgbClr val="000000"/>
                </a:solidFill>
                <a:uFillTx/>
                <a:latin typeface="Arial"/>
              </a:rPr>
              <a:t>Figure S1 - Martuszewska </a:t>
            </a:r>
            <a:r>
              <a:rPr b="0" i="1" lang="en-US" sz="1400" spc="-1" strike="noStrike" u="sng">
                <a:solidFill>
                  <a:srgbClr val="000000"/>
                </a:solidFill>
                <a:uFillTx/>
                <a:latin typeface="Arial"/>
              </a:rPr>
              <a:t>et al</a:t>
            </a:r>
            <a:r>
              <a:rPr b="0" lang="en-US" sz="1400" spc="-1" strike="noStrike" u="sng">
                <a:solidFill>
                  <a:srgbClr val="000000"/>
                </a:solidFill>
                <a:uFillTx/>
                <a:latin typeface="Arial"/>
              </a:rPr>
              <a:t>.</a:t>
            </a:r>
            <a:endParaRPr b="0" lang="en-US" sz="1400" spc="-1" strike="noStrike">
              <a:solidFill>
                <a:srgbClr val="000000"/>
              </a:solidFill>
              <a:latin typeface="Arial"/>
            </a:endParaRPr>
          </a:p>
        </p:txBody>
      </p:sp>
      <p:sp>
        <p:nvSpPr>
          <p:cNvPr id="42" name=""/>
          <p:cNvSpPr/>
          <p:nvPr/>
        </p:nvSpPr>
        <p:spPr>
          <a:xfrm>
            <a:off x="3886200" y="2057400"/>
            <a:ext cx="944280" cy="3070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Anti-Tns3</a:t>
            </a:r>
            <a:endParaRPr b="0" lang="en-US" sz="1400" spc="-1" strike="noStrike">
              <a:solidFill>
                <a:srgbClr val="000000"/>
              </a:solidFill>
              <a:latin typeface="Arial"/>
            </a:endParaRPr>
          </a:p>
        </p:txBody>
      </p:sp>
      <p:pic>
        <p:nvPicPr>
          <p:cNvPr id="43" name="" descr=""/>
          <p:cNvPicPr/>
          <p:nvPr/>
        </p:nvPicPr>
        <p:blipFill>
          <a:blip r:embed="rId1"/>
          <a:stretch/>
        </p:blipFill>
        <p:spPr>
          <a:xfrm>
            <a:off x="1447920" y="3200400"/>
            <a:ext cx="2361960" cy="1765440"/>
          </a:xfrm>
          <a:prstGeom prst="rect">
            <a:avLst/>
          </a:prstGeom>
          <a:ln w="19080">
            <a:solidFill>
              <a:srgbClr val="000000"/>
            </a:solidFill>
            <a:miter/>
          </a:ln>
        </p:spPr>
      </p:pic>
      <p:pic>
        <p:nvPicPr>
          <p:cNvPr id="44" name="" descr=""/>
          <p:cNvPicPr/>
          <p:nvPr/>
        </p:nvPicPr>
        <p:blipFill>
          <a:blip r:embed="rId2"/>
          <a:stretch/>
        </p:blipFill>
        <p:spPr>
          <a:xfrm>
            <a:off x="1447920" y="1371600"/>
            <a:ext cx="2361960" cy="1765440"/>
          </a:xfrm>
          <a:prstGeom prst="rect">
            <a:avLst/>
          </a:prstGeom>
          <a:ln w="19080">
            <a:solidFill>
              <a:srgbClr val="000000"/>
            </a:solidFill>
            <a:miter/>
          </a:ln>
        </p:spPr>
      </p:pic>
      <p:pic>
        <p:nvPicPr>
          <p:cNvPr id="45" name="" descr=""/>
          <p:cNvPicPr/>
          <p:nvPr/>
        </p:nvPicPr>
        <p:blipFill>
          <a:blip r:embed="rId3">
            <a:lum contrast="12000"/>
          </a:blip>
          <a:stretch/>
        </p:blipFill>
        <p:spPr>
          <a:xfrm>
            <a:off x="1447920" y="5029200"/>
            <a:ext cx="2361960" cy="1765440"/>
          </a:xfrm>
          <a:prstGeom prst="rect">
            <a:avLst/>
          </a:prstGeom>
          <a:ln w="19080">
            <a:solidFill>
              <a:srgbClr val="000000"/>
            </a:solidFill>
            <a:miter/>
          </a:ln>
        </p:spPr>
      </p:pic>
      <p:sp>
        <p:nvSpPr>
          <p:cNvPr id="46" name=""/>
          <p:cNvSpPr/>
          <p:nvPr/>
        </p:nvSpPr>
        <p:spPr>
          <a:xfrm>
            <a:off x="3885840" y="3809880"/>
            <a:ext cx="1188000" cy="5202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Anti-Tns3</a:t>
            </a:r>
            <a:endParaRPr b="0" lang="en-US" sz="14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 peptide Ag</a:t>
            </a:r>
            <a:endParaRPr b="0" lang="en-US" sz="1400" spc="-1" strike="noStrike">
              <a:solidFill>
                <a:srgbClr val="000000"/>
              </a:solidFill>
              <a:latin typeface="Arial"/>
            </a:endParaRPr>
          </a:p>
        </p:txBody>
      </p:sp>
      <p:sp>
        <p:nvSpPr>
          <p:cNvPr id="47" name=""/>
          <p:cNvSpPr/>
          <p:nvPr/>
        </p:nvSpPr>
        <p:spPr>
          <a:xfrm>
            <a:off x="3883320" y="5638680"/>
            <a:ext cx="2398320" cy="5202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Anti-Tns3</a:t>
            </a:r>
            <a:endParaRPr b="0" lang="en-US" sz="14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 rec. Tns3 PTPase domain</a:t>
            </a:r>
            <a:endParaRPr b="0" lang="en-US" sz="1400" spc="-1" strike="noStrike">
              <a:solidFill>
                <a:srgbClr val="000000"/>
              </a:solidFill>
              <a:latin typeface="Arial"/>
            </a:endParaRPr>
          </a:p>
        </p:txBody>
      </p:sp>
      <p:sp>
        <p:nvSpPr>
          <p:cNvPr id="48" name=""/>
          <p:cNvSpPr/>
          <p:nvPr/>
        </p:nvSpPr>
        <p:spPr>
          <a:xfrm>
            <a:off x="1600200" y="3048120"/>
            <a:ext cx="228600" cy="0"/>
          </a:xfrm>
          <a:prstGeom prst="line">
            <a:avLst/>
          </a:prstGeom>
          <a:ln w="19080">
            <a:solidFill>
              <a:srgbClr val="000000"/>
            </a:solidFill>
            <a:miter/>
          </a:ln>
        </p:spPr>
        <p:style>
          <a:lnRef idx="0"/>
          <a:fillRef idx="0"/>
          <a:effectRef idx="0"/>
          <a:fontRef idx="minor"/>
        </p:style>
        <p:txBody>
          <a:bodyPr lIns="90000" rIns="90000" tIns="-46800" bIns="-46800" anchor="ctr">
            <a:noAutofit/>
          </a:bodyPr>
          <a:p>
            <a:endParaRPr b="0" lang="en-US" sz="2400" spc="-1" strike="noStrike">
              <a:solidFill>
                <a:srgbClr val="000000"/>
              </a:solidFill>
              <a:latin typeface="Arial"/>
            </a:endParaRPr>
          </a:p>
        </p:txBody>
      </p:sp>
      <p:sp>
        <p:nvSpPr>
          <p:cNvPr id="49" name=""/>
          <p:cNvSpPr/>
          <p:nvPr/>
        </p:nvSpPr>
        <p:spPr>
          <a:xfrm>
            <a:off x="380880" y="7315200"/>
            <a:ext cx="5883480" cy="15541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Times New Roman"/>
              </a:rPr>
              <a:t>Polyclonal anti-Tensin3 (Tns3) antibody was verified for specificity by antigen blocking. Antibody was incubated overnight at the optimal dilution of 1:300 either alone (A), or together with the peptide antigen it was raised against (Ag; B), or with the recombinant phosphatase domain of Tns3 (PTPase, negative control, C). Potential immune complexes were removed by centrifugation, followed by immunohistochemical testing of the mixtures on normal human kidney section as described (Methods). Bar represents 15 </a:t>
            </a:r>
            <a:r>
              <a:rPr b="0" lang="en-US" sz="1200" spc="-1" strike="noStrike">
                <a:solidFill>
                  <a:srgbClr val="000000"/>
                </a:solidFill>
                <a:latin typeface="Symbol"/>
                <a:ea typeface="Symbol"/>
              </a:rPr>
              <a:t></a:t>
            </a:r>
            <a:r>
              <a:rPr b="0" lang="en-US" sz="1200" spc="-1" strike="noStrike">
                <a:solidFill>
                  <a:srgbClr val="000000"/>
                </a:solidFill>
                <a:latin typeface="Times New Roman"/>
              </a:rPr>
              <a:t>m. Note that Tns3 immunoreactivity is completely blocked by the relevant antigen (B) but not by an irrelevant antigen from the same protein (C). </a:t>
            </a:r>
            <a:endParaRPr b="0" lang="en-US" sz="1200" spc="-1" strike="noStrike">
              <a:solidFill>
                <a:srgbClr val="000000"/>
              </a:solidFill>
              <a:latin typeface="Arial"/>
            </a:endParaRPr>
          </a:p>
        </p:txBody>
      </p:sp>
      <p:sp>
        <p:nvSpPr>
          <p:cNvPr id="50" name=""/>
          <p:cNvSpPr/>
          <p:nvPr/>
        </p:nvSpPr>
        <p:spPr>
          <a:xfrm>
            <a:off x="992520" y="1371600"/>
            <a:ext cx="383400" cy="4597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A</a:t>
            </a:r>
            <a:endParaRPr b="0" lang="en-US" sz="2400" spc="-1" strike="noStrike">
              <a:solidFill>
                <a:srgbClr val="000000"/>
              </a:solidFill>
              <a:latin typeface="Arial"/>
            </a:endParaRPr>
          </a:p>
        </p:txBody>
      </p:sp>
      <p:sp>
        <p:nvSpPr>
          <p:cNvPr id="51" name=""/>
          <p:cNvSpPr/>
          <p:nvPr/>
        </p:nvSpPr>
        <p:spPr>
          <a:xfrm>
            <a:off x="992880" y="5029200"/>
            <a:ext cx="400320" cy="4597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C</a:t>
            </a:r>
            <a:endParaRPr b="0" lang="en-US" sz="2400" spc="-1" strike="noStrike">
              <a:solidFill>
                <a:srgbClr val="000000"/>
              </a:solidFill>
              <a:latin typeface="Arial"/>
            </a:endParaRPr>
          </a:p>
        </p:txBody>
      </p:sp>
      <p:sp>
        <p:nvSpPr>
          <p:cNvPr id="52" name=""/>
          <p:cNvSpPr/>
          <p:nvPr/>
        </p:nvSpPr>
        <p:spPr>
          <a:xfrm>
            <a:off x="992520" y="3200400"/>
            <a:ext cx="383400" cy="4597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a:solidFill>
                  <a:srgbClr val="000000"/>
                </a:solidFill>
                <a:latin typeface="Arial"/>
              </a:rPr>
              <a:t>B</a:t>
            </a:r>
            <a:endParaRPr b="0" lang="en-US" sz="2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38</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6-05-08T11:08:26Z</dcterms:created>
  <dc:creator>Sassan Hafizi</dc:creator>
  <dc:description/>
  <dc:language>en-US</dc:language>
  <cp:lastModifiedBy>Sassan Hafizi</cp:lastModifiedBy>
  <cp:lastPrinted>2008-08-15T14:00:49Z</cp:lastPrinted>
  <dcterms:modified xsi:type="dcterms:W3CDTF">2009-01-07T11:11:11Z</dcterms:modified>
  <cp:revision>15</cp:revision>
  <dc:subject/>
  <dc:title>PowerPoint Presentation</dc:title>
</cp:coreProperties>
</file>